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840" userDrawn="1">
          <p15:clr>
            <a:srgbClr val="A4A3A4"/>
          </p15:clr>
        </p15:guide>
        <p15:guide id="3" orient="horz" pos="21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241" autoAdjust="0"/>
    <p:restoredTop sz="94660"/>
  </p:normalViewPr>
  <p:slideViewPr>
    <p:cSldViewPr snapToGrid="0" showGuides="1">
      <p:cViewPr varScale="1">
        <p:scale>
          <a:sx n="57" d="100"/>
          <a:sy n="57" d="100"/>
        </p:scale>
        <p:origin x="108" y="1128"/>
      </p:cViewPr>
      <p:guideLst>
        <p:guide pos="3840"/>
        <p:guide orient="horz" pos="218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17308-F72D-4563-A7EA-190C45DC42A8}" type="datetimeFigureOut">
              <a:rPr lang="ko-KR" altLang="en-US" smtClean="0"/>
              <a:t>2025-08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22FA4-C843-465B-9641-A4AC2825E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9520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17308-F72D-4563-A7EA-190C45DC42A8}" type="datetimeFigureOut">
              <a:rPr lang="ko-KR" altLang="en-US" smtClean="0"/>
              <a:t>2025-08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22FA4-C843-465B-9641-A4AC2825E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5350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17308-F72D-4563-A7EA-190C45DC42A8}" type="datetimeFigureOut">
              <a:rPr lang="ko-KR" altLang="en-US" smtClean="0"/>
              <a:t>2025-08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22FA4-C843-465B-9641-A4AC2825E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22501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17308-F72D-4563-A7EA-190C45DC42A8}" type="datetimeFigureOut">
              <a:rPr lang="ko-KR" altLang="en-US" smtClean="0"/>
              <a:t>2025-08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22FA4-C843-465B-9641-A4AC2825E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117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17308-F72D-4563-A7EA-190C45DC42A8}" type="datetimeFigureOut">
              <a:rPr lang="ko-KR" altLang="en-US" smtClean="0"/>
              <a:t>2025-08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22FA4-C843-465B-9641-A4AC2825E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4894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17308-F72D-4563-A7EA-190C45DC42A8}" type="datetimeFigureOut">
              <a:rPr lang="ko-KR" altLang="en-US" smtClean="0"/>
              <a:t>2025-08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22FA4-C843-465B-9641-A4AC2825E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6376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17308-F72D-4563-A7EA-190C45DC42A8}" type="datetimeFigureOut">
              <a:rPr lang="ko-KR" altLang="en-US" smtClean="0"/>
              <a:t>2025-08-0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22FA4-C843-465B-9641-A4AC2825E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92862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17308-F72D-4563-A7EA-190C45DC42A8}" type="datetimeFigureOut">
              <a:rPr lang="ko-KR" altLang="en-US" smtClean="0"/>
              <a:t>2025-08-0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22FA4-C843-465B-9641-A4AC2825E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58565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17308-F72D-4563-A7EA-190C45DC42A8}" type="datetimeFigureOut">
              <a:rPr lang="ko-KR" altLang="en-US" smtClean="0"/>
              <a:t>2025-08-0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22FA4-C843-465B-9641-A4AC2825E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63154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17308-F72D-4563-A7EA-190C45DC42A8}" type="datetimeFigureOut">
              <a:rPr lang="ko-KR" altLang="en-US" smtClean="0"/>
              <a:t>2025-08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22FA4-C843-465B-9641-A4AC2825E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87287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317308-F72D-4563-A7EA-190C45DC42A8}" type="datetimeFigureOut">
              <a:rPr lang="ko-KR" altLang="en-US" smtClean="0"/>
              <a:t>2025-08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22FA4-C843-465B-9641-A4AC2825E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29693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317308-F72D-4563-A7EA-190C45DC42A8}" type="datetimeFigureOut">
              <a:rPr lang="ko-KR" altLang="en-US" smtClean="0"/>
              <a:t>2025-08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622FA4-C843-465B-9641-A4AC2825E2F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70481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그룹 4"/>
          <p:cNvGrpSpPr/>
          <p:nvPr/>
        </p:nvGrpSpPr>
        <p:grpSpPr>
          <a:xfrm>
            <a:off x="3180523" y="1046479"/>
            <a:ext cx="2548684" cy="2421468"/>
            <a:chOff x="3180523" y="1046479"/>
            <a:chExt cx="2548684" cy="2421468"/>
          </a:xfrm>
        </p:grpSpPr>
        <p:grpSp>
          <p:nvGrpSpPr>
            <p:cNvPr id="57" name="그룹 56"/>
            <p:cNvGrpSpPr/>
            <p:nvPr/>
          </p:nvGrpSpPr>
          <p:grpSpPr>
            <a:xfrm>
              <a:off x="3180523" y="1046479"/>
              <a:ext cx="2498817" cy="2321441"/>
              <a:chOff x="3545457" y="1101941"/>
              <a:chExt cx="2498817" cy="2321441"/>
            </a:xfrm>
          </p:grpSpPr>
          <p:grpSp>
            <p:nvGrpSpPr>
              <p:cNvPr id="40" name="그룹 39"/>
              <p:cNvGrpSpPr/>
              <p:nvPr/>
            </p:nvGrpSpPr>
            <p:grpSpPr>
              <a:xfrm>
                <a:off x="3545457" y="1101941"/>
                <a:ext cx="2498817" cy="2321441"/>
                <a:chOff x="3545457" y="1101941"/>
                <a:chExt cx="2498817" cy="2321441"/>
              </a:xfrm>
            </p:grpSpPr>
            <p:pic>
              <p:nvPicPr>
                <p:cNvPr id="15" name="그림 14"/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862" t="2365" r="27399" b="15425"/>
                <a:stretch/>
              </p:blipFill>
              <p:spPr>
                <a:xfrm>
                  <a:off x="4045312" y="1405058"/>
                  <a:ext cx="1998962" cy="1940170"/>
                </a:xfrm>
                <a:prstGeom prst="rect">
                  <a:avLst/>
                </a:prstGeom>
              </p:spPr>
            </p:pic>
            <p:sp>
              <p:nvSpPr>
                <p:cNvPr id="19" name="TextBox 18"/>
                <p:cNvSpPr txBox="1"/>
                <p:nvPr/>
              </p:nvSpPr>
              <p:spPr>
                <a:xfrm>
                  <a:off x="4045312" y="1101941"/>
                  <a:ext cx="1996825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b="1" dirty="0" smtClean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DH</a:t>
                  </a:r>
                  <a:endParaRPr lang="ko-KR" altLang="en-US" sz="14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" name="오른쪽 화살표 32"/>
                <p:cNvSpPr/>
                <p:nvPr/>
              </p:nvSpPr>
              <p:spPr>
                <a:xfrm>
                  <a:off x="4254235" y="3125782"/>
                  <a:ext cx="189961" cy="87415"/>
                </a:xfrm>
                <a:prstGeom prst="rightArrow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3545457" y="2961717"/>
                  <a:ext cx="726707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1200" dirty="0" smtClean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DH</a:t>
                  </a:r>
                </a:p>
                <a:p>
                  <a:pPr algn="r"/>
                  <a:r>
                    <a:rPr lang="en-US" altLang="ko-KR" sz="1200" dirty="0" smtClean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7 </a:t>
                  </a:r>
                  <a:r>
                    <a:rPr lang="en-US" altLang="ko-KR" sz="1200" dirty="0" err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ko-KR" altLang="en-US" sz="12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56" name="직사각형 55"/>
              <p:cNvSpPr/>
              <p:nvPr/>
            </p:nvSpPr>
            <p:spPr>
              <a:xfrm>
                <a:off x="4507652" y="3052183"/>
                <a:ext cx="1447292" cy="24025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69" name="TextBox 68"/>
            <p:cNvSpPr txBox="1"/>
            <p:nvPr/>
          </p:nvSpPr>
          <p:spPr>
            <a:xfrm>
              <a:off x="4075987" y="3267892"/>
              <a:ext cx="16532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</a:t>
              </a:r>
              <a:r>
                <a:rPr lang="en-US" altLang="ko-KR" sz="7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lang="en-US" altLang="ko-KR" sz="7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FHFr</a:t>
              </a:r>
              <a:r>
                <a:rPr lang="en-US" altLang="ko-KR" sz="7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OMT  AAL1  AAL2</a:t>
              </a:r>
              <a:endParaRPr lang="ko-KR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" name="그룹 2"/>
          <p:cNvGrpSpPr/>
          <p:nvPr/>
        </p:nvGrpSpPr>
        <p:grpSpPr>
          <a:xfrm>
            <a:off x="385203" y="1036715"/>
            <a:ext cx="2655976" cy="2431232"/>
            <a:chOff x="385203" y="1036715"/>
            <a:chExt cx="2655976" cy="2431232"/>
          </a:xfrm>
        </p:grpSpPr>
        <p:grpSp>
          <p:nvGrpSpPr>
            <p:cNvPr id="28" name="그룹 27"/>
            <p:cNvGrpSpPr/>
            <p:nvPr/>
          </p:nvGrpSpPr>
          <p:grpSpPr>
            <a:xfrm>
              <a:off x="385203" y="1036715"/>
              <a:ext cx="2543777" cy="2257714"/>
              <a:chOff x="385203" y="1087514"/>
              <a:chExt cx="2543777" cy="2257714"/>
            </a:xfrm>
          </p:grpSpPr>
          <p:pic>
            <p:nvPicPr>
              <p:cNvPr id="14" name="그림 13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607" t="3123" r="23137" b="17781"/>
              <a:stretch/>
            </p:blipFill>
            <p:spPr>
              <a:xfrm>
                <a:off x="987105" y="1405058"/>
                <a:ext cx="1940170" cy="1940170"/>
              </a:xfrm>
              <a:prstGeom prst="rect">
                <a:avLst/>
              </a:prstGeom>
            </p:spPr>
          </p:pic>
          <p:sp>
            <p:nvSpPr>
              <p:cNvPr id="17" name="TextBox 16"/>
              <p:cNvSpPr txBox="1"/>
              <p:nvPr/>
            </p:nvSpPr>
            <p:spPr>
              <a:xfrm>
                <a:off x="987106" y="1087514"/>
                <a:ext cx="1941874" cy="3128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AMPK</a:t>
                </a:r>
                <a:endParaRPr lang="ko-KR" altLang="en-US" sz="14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직사각형 20"/>
              <p:cNvSpPr/>
              <p:nvPr/>
            </p:nvSpPr>
            <p:spPr>
              <a:xfrm>
                <a:off x="1394694" y="2071624"/>
                <a:ext cx="1447292" cy="24025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2" name="오른쪽 화살표 21"/>
              <p:cNvSpPr/>
              <p:nvPr/>
            </p:nvSpPr>
            <p:spPr>
              <a:xfrm>
                <a:off x="1132148" y="2141237"/>
                <a:ext cx="189961" cy="87415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385203" y="1977172"/>
                <a:ext cx="764874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200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AMPK</a:t>
                </a:r>
              </a:p>
              <a:p>
                <a:pPr algn="r"/>
                <a:r>
                  <a:rPr lang="en-US" altLang="ko-KR" sz="1200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63 </a:t>
                </a:r>
                <a:r>
                  <a:rPr lang="en-US" altLang="ko-KR" sz="1200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</a:t>
                </a:r>
                <a:r>
                  <a:rPr lang="en-US" altLang="ko-KR" sz="1200" dirty="0" err="1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</a:t>
                </a:r>
                <a:endParaRPr lang="ko-KR" altLang="en-US" sz="12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2" name="TextBox 71"/>
            <p:cNvSpPr txBox="1"/>
            <p:nvPr/>
          </p:nvSpPr>
          <p:spPr>
            <a:xfrm>
              <a:off x="1387959" y="3267892"/>
              <a:ext cx="16532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</a:t>
              </a:r>
              <a:r>
                <a:rPr lang="en-US" altLang="ko-KR" sz="7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lang="en-US" altLang="ko-KR" sz="7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FHFr</a:t>
              </a:r>
              <a:r>
                <a:rPr lang="en-US" altLang="ko-KR" sz="7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OMT  AAL1  AAL2</a:t>
              </a:r>
              <a:endParaRPr lang="ko-KR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" name="그룹 10"/>
          <p:cNvGrpSpPr/>
          <p:nvPr/>
        </p:nvGrpSpPr>
        <p:grpSpPr>
          <a:xfrm>
            <a:off x="264457" y="3654815"/>
            <a:ext cx="2757400" cy="2204302"/>
            <a:chOff x="264457" y="3654815"/>
            <a:chExt cx="2757400" cy="2204302"/>
          </a:xfrm>
        </p:grpSpPr>
        <p:grpSp>
          <p:nvGrpSpPr>
            <p:cNvPr id="54" name="그룹 53"/>
            <p:cNvGrpSpPr/>
            <p:nvPr/>
          </p:nvGrpSpPr>
          <p:grpSpPr>
            <a:xfrm>
              <a:off x="264457" y="3654815"/>
              <a:ext cx="2662818" cy="2030279"/>
              <a:chOff x="264457" y="3874944"/>
              <a:chExt cx="2662818" cy="2030279"/>
            </a:xfrm>
          </p:grpSpPr>
          <p:grpSp>
            <p:nvGrpSpPr>
              <p:cNvPr id="27" name="그룹 26"/>
              <p:cNvGrpSpPr/>
              <p:nvPr/>
            </p:nvGrpSpPr>
            <p:grpSpPr>
              <a:xfrm>
                <a:off x="987105" y="3874944"/>
                <a:ext cx="1940170" cy="2030279"/>
                <a:chOff x="987105" y="3874944"/>
                <a:chExt cx="1940170" cy="2030279"/>
              </a:xfrm>
            </p:grpSpPr>
            <p:pic>
              <p:nvPicPr>
                <p:cNvPr id="16" name="그림 15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7121" t="2532" r="18051" b="28337"/>
                <a:stretch/>
              </p:blipFill>
              <p:spPr>
                <a:xfrm>
                  <a:off x="1322109" y="4149306"/>
                  <a:ext cx="1596835" cy="1755917"/>
                </a:xfrm>
                <a:prstGeom prst="rect">
                  <a:avLst/>
                </a:prstGeom>
              </p:spPr>
            </p:pic>
            <p:sp>
              <p:nvSpPr>
                <p:cNvPr id="18" name="TextBox 17"/>
                <p:cNvSpPr txBox="1"/>
                <p:nvPr/>
              </p:nvSpPr>
              <p:spPr>
                <a:xfrm>
                  <a:off x="987105" y="3874944"/>
                  <a:ext cx="194017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b="1" dirty="0" smtClean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-AMPK</a:t>
                  </a:r>
                  <a:endParaRPr lang="ko-KR" altLang="en-US" sz="14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50" name="직사각형 49"/>
              <p:cNvSpPr/>
              <p:nvPr/>
            </p:nvSpPr>
            <p:spPr>
              <a:xfrm>
                <a:off x="1313151" y="4785668"/>
                <a:ext cx="1447292" cy="24025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1" name="오른쪽 화살표 50"/>
              <p:cNvSpPr/>
              <p:nvPr/>
            </p:nvSpPr>
            <p:spPr>
              <a:xfrm>
                <a:off x="1050605" y="4855281"/>
                <a:ext cx="189961" cy="87415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264457" y="4691216"/>
                <a:ext cx="80407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200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AMPK</a:t>
                </a:r>
              </a:p>
              <a:p>
                <a:pPr algn="r"/>
                <a:r>
                  <a:rPr lang="en-US" altLang="ko-KR" sz="1200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63 </a:t>
                </a:r>
                <a:r>
                  <a:rPr lang="en-US" altLang="ko-KR" sz="1200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</a:t>
                </a:r>
                <a:r>
                  <a:rPr lang="en-US" altLang="ko-KR" sz="1200" dirty="0" err="1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</a:t>
                </a:r>
                <a:endParaRPr lang="ko-KR" altLang="en-US" sz="12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83" name="TextBox 82"/>
            <p:cNvSpPr txBox="1"/>
            <p:nvPr/>
          </p:nvSpPr>
          <p:spPr>
            <a:xfrm>
              <a:off x="1368637" y="5659062"/>
              <a:ext cx="16532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</a:t>
              </a:r>
              <a:r>
                <a:rPr lang="en-US" altLang="ko-KR" sz="7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lang="en-US" altLang="ko-KR" sz="7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FHFr</a:t>
              </a:r>
              <a:r>
                <a:rPr lang="en-US" altLang="ko-KR" sz="7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OMT  AAL1  AAL2</a:t>
              </a:r>
              <a:endParaRPr lang="ko-KR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" name="그룹 9"/>
          <p:cNvGrpSpPr/>
          <p:nvPr/>
        </p:nvGrpSpPr>
        <p:grpSpPr>
          <a:xfrm>
            <a:off x="3117051" y="3619080"/>
            <a:ext cx="2563306" cy="2240037"/>
            <a:chOff x="3117051" y="3619080"/>
            <a:chExt cx="2563306" cy="2240037"/>
          </a:xfrm>
        </p:grpSpPr>
        <p:grpSp>
          <p:nvGrpSpPr>
            <p:cNvPr id="58" name="그룹 57"/>
            <p:cNvGrpSpPr/>
            <p:nvPr/>
          </p:nvGrpSpPr>
          <p:grpSpPr>
            <a:xfrm>
              <a:off x="3117051" y="3619080"/>
              <a:ext cx="2531578" cy="2066014"/>
              <a:chOff x="3512695" y="3860333"/>
              <a:chExt cx="2531578" cy="2066014"/>
            </a:xfrm>
          </p:grpSpPr>
          <p:grpSp>
            <p:nvGrpSpPr>
              <p:cNvPr id="39" name="그룹 38"/>
              <p:cNvGrpSpPr/>
              <p:nvPr/>
            </p:nvGrpSpPr>
            <p:grpSpPr>
              <a:xfrm>
                <a:off x="3512695" y="3860333"/>
                <a:ext cx="2531578" cy="2066014"/>
                <a:chOff x="3512695" y="3860333"/>
                <a:chExt cx="2531578" cy="2066014"/>
              </a:xfrm>
            </p:grpSpPr>
            <p:pic>
              <p:nvPicPr>
                <p:cNvPr id="4" name="그림 3"/>
                <p:cNvPicPr>
                  <a:picLocks noChangeAspect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222" t="-188" r="15057" b="18601"/>
                <a:stretch/>
              </p:blipFill>
              <p:spPr>
                <a:xfrm>
                  <a:off x="4045268" y="4132720"/>
                  <a:ext cx="1999005" cy="1793627"/>
                </a:xfrm>
                <a:prstGeom prst="rect">
                  <a:avLst/>
                </a:prstGeom>
              </p:spPr>
            </p:pic>
            <p:sp>
              <p:nvSpPr>
                <p:cNvPr id="35" name="TextBox 34"/>
                <p:cNvSpPr txBox="1"/>
                <p:nvPr/>
              </p:nvSpPr>
              <p:spPr>
                <a:xfrm>
                  <a:off x="4076022" y="3860333"/>
                  <a:ext cx="1941357" cy="31009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b="1" dirty="0" smtClean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DH</a:t>
                  </a:r>
                  <a:endParaRPr lang="ko-KR" altLang="en-US" sz="14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오른쪽 화살표 36"/>
                <p:cNvSpPr/>
                <p:nvPr/>
              </p:nvSpPr>
              <p:spPr>
                <a:xfrm>
                  <a:off x="4236306" y="5279634"/>
                  <a:ext cx="189961" cy="87415"/>
                </a:xfrm>
                <a:prstGeom prst="rightArrow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>
                  <a:off x="3512695" y="5115569"/>
                  <a:ext cx="741540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ko-KR" sz="1200" dirty="0" smtClean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APDH</a:t>
                  </a:r>
                </a:p>
                <a:p>
                  <a:pPr algn="r"/>
                  <a:r>
                    <a:rPr lang="en-US" altLang="ko-KR" sz="1200" dirty="0" smtClean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7 </a:t>
                  </a:r>
                  <a:r>
                    <a:rPr lang="en-US" altLang="ko-KR" sz="1200" dirty="0" err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kDa</a:t>
                  </a:r>
                  <a:endParaRPr lang="ko-KR" altLang="en-US" sz="12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55" name="직사각형 54"/>
              <p:cNvSpPr/>
              <p:nvPr/>
            </p:nvSpPr>
            <p:spPr>
              <a:xfrm>
                <a:off x="4488564" y="5197889"/>
                <a:ext cx="1447292" cy="24025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84" name="TextBox 83"/>
            <p:cNvSpPr txBox="1"/>
            <p:nvPr/>
          </p:nvSpPr>
          <p:spPr>
            <a:xfrm>
              <a:off x="4027137" y="5659062"/>
              <a:ext cx="16532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</a:t>
              </a:r>
              <a:r>
                <a:rPr lang="en-US" altLang="ko-KR" sz="7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lang="en-US" altLang="ko-KR" sz="7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FHFr</a:t>
              </a:r>
              <a:r>
                <a:rPr lang="en-US" altLang="ko-KR" sz="7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OMT  AAL1  AAL2</a:t>
              </a:r>
              <a:endParaRPr lang="ko-KR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" name="그룹 8"/>
          <p:cNvGrpSpPr/>
          <p:nvPr/>
        </p:nvGrpSpPr>
        <p:grpSpPr>
          <a:xfrm>
            <a:off x="6016906" y="3654931"/>
            <a:ext cx="2920832" cy="2283428"/>
            <a:chOff x="6016906" y="3654931"/>
            <a:chExt cx="2920832" cy="2283428"/>
          </a:xfrm>
        </p:grpSpPr>
        <p:grpSp>
          <p:nvGrpSpPr>
            <p:cNvPr id="81" name="그룹 80"/>
            <p:cNvGrpSpPr/>
            <p:nvPr/>
          </p:nvGrpSpPr>
          <p:grpSpPr>
            <a:xfrm>
              <a:off x="6016906" y="3654931"/>
              <a:ext cx="2920832" cy="2206083"/>
              <a:chOff x="5934974" y="3899701"/>
              <a:chExt cx="2920832" cy="2206083"/>
            </a:xfrm>
          </p:grpSpPr>
          <p:pic>
            <p:nvPicPr>
              <p:cNvPr id="71" name="그림 70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169" t="8914" r="22107" b="9071"/>
              <a:stretch/>
            </p:blipFill>
            <p:spPr>
              <a:xfrm>
                <a:off x="6750415" y="4180406"/>
                <a:ext cx="2105391" cy="1925378"/>
              </a:xfrm>
              <a:prstGeom prst="rect">
                <a:avLst/>
              </a:prstGeom>
            </p:spPr>
          </p:pic>
          <p:sp>
            <p:nvSpPr>
              <p:cNvPr id="73" name="TextBox 72"/>
              <p:cNvSpPr txBox="1"/>
              <p:nvPr/>
            </p:nvSpPr>
            <p:spPr>
              <a:xfrm>
                <a:off x="6779844" y="3899701"/>
                <a:ext cx="207464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SMAD2</a:t>
                </a:r>
                <a:endParaRPr lang="ko-KR" altLang="en-US" sz="14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오른쪽 화살표 73"/>
              <p:cNvSpPr/>
              <p:nvPr/>
            </p:nvSpPr>
            <p:spPr>
              <a:xfrm>
                <a:off x="6889908" y="5658985"/>
                <a:ext cx="189961" cy="87415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5934974" y="5494920"/>
                <a:ext cx="97286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2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GF-β </a:t>
                </a:r>
                <a:endParaRPr lang="en-US" altLang="ko-KR" sz="1200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altLang="ko-KR" sz="1200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.5-25 </a:t>
                </a:r>
                <a:r>
                  <a:rPr lang="en-US" altLang="ko-KR" sz="1200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ko-KR" altLang="en-US" sz="12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직사각형 75"/>
              <p:cNvSpPr/>
              <p:nvPr/>
            </p:nvSpPr>
            <p:spPr>
              <a:xfrm>
                <a:off x="7143325" y="5585386"/>
                <a:ext cx="1447292" cy="24025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85" name="TextBox 84"/>
            <p:cNvSpPr txBox="1"/>
            <p:nvPr/>
          </p:nvSpPr>
          <p:spPr>
            <a:xfrm>
              <a:off x="7173946" y="5738304"/>
              <a:ext cx="16532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</a:t>
              </a:r>
              <a:r>
                <a:rPr lang="en-US" altLang="ko-KR" sz="7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</a:t>
              </a:r>
              <a:r>
                <a:rPr lang="en-US" altLang="ko-KR" sz="7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FHFr</a:t>
              </a:r>
              <a:r>
                <a:rPr lang="en-US" altLang="ko-KR" sz="7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OMT   AAL1   AAL2</a:t>
              </a:r>
              <a:endParaRPr lang="ko-KR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" name="그룹 7"/>
          <p:cNvGrpSpPr/>
          <p:nvPr/>
        </p:nvGrpSpPr>
        <p:grpSpPr>
          <a:xfrm>
            <a:off x="8986169" y="3646359"/>
            <a:ext cx="2570767" cy="2292000"/>
            <a:chOff x="8986169" y="3646359"/>
            <a:chExt cx="2570767" cy="2292000"/>
          </a:xfrm>
        </p:grpSpPr>
        <p:grpSp>
          <p:nvGrpSpPr>
            <p:cNvPr id="82" name="그룹 81"/>
            <p:cNvGrpSpPr/>
            <p:nvPr/>
          </p:nvGrpSpPr>
          <p:grpSpPr>
            <a:xfrm>
              <a:off x="8986169" y="3646359"/>
              <a:ext cx="2570767" cy="2222888"/>
              <a:chOff x="8904237" y="3891129"/>
              <a:chExt cx="2570767" cy="2222888"/>
            </a:xfrm>
          </p:grpSpPr>
          <p:pic>
            <p:nvPicPr>
              <p:cNvPr id="70" name="그림 69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715" t="2109" r="24531" b="23778"/>
              <a:stretch/>
            </p:blipFill>
            <p:spPr>
              <a:xfrm>
                <a:off x="9402791" y="4179274"/>
                <a:ext cx="2072213" cy="1926510"/>
              </a:xfrm>
              <a:prstGeom prst="rect">
                <a:avLst/>
              </a:prstGeom>
            </p:spPr>
          </p:pic>
          <p:sp>
            <p:nvSpPr>
              <p:cNvPr id="77" name="TextBox 76"/>
              <p:cNvSpPr txBox="1"/>
              <p:nvPr/>
            </p:nvSpPr>
            <p:spPr>
              <a:xfrm>
                <a:off x="9402791" y="3891129"/>
                <a:ext cx="207221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ko-KR" altLang="en-US" sz="14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오른쪽 화살표 77"/>
              <p:cNvSpPr/>
              <p:nvPr/>
            </p:nvSpPr>
            <p:spPr>
              <a:xfrm>
                <a:off x="9613015" y="5816417"/>
                <a:ext cx="189961" cy="87415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>
                <a:off x="8904237" y="5652352"/>
                <a:ext cx="72670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200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</a:p>
              <a:p>
                <a:pPr algn="r"/>
                <a:r>
                  <a:rPr lang="en-US" altLang="ko-KR" sz="1200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7 </a:t>
                </a:r>
                <a:r>
                  <a:rPr lang="en-US" altLang="ko-KR" sz="1200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ko-KR" altLang="en-US" sz="12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직사각형 79"/>
              <p:cNvSpPr/>
              <p:nvPr/>
            </p:nvSpPr>
            <p:spPr>
              <a:xfrm>
                <a:off x="9866432" y="5742818"/>
                <a:ext cx="1447292" cy="24025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86" name="TextBox 85"/>
            <p:cNvSpPr txBox="1"/>
            <p:nvPr/>
          </p:nvSpPr>
          <p:spPr>
            <a:xfrm>
              <a:off x="9846011" y="5738304"/>
              <a:ext cx="16532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</a:t>
              </a:r>
              <a:r>
                <a:rPr lang="en-US" altLang="ko-KR" sz="7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</a:t>
              </a:r>
              <a:r>
                <a:rPr lang="en-US" altLang="ko-KR" sz="7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FHFr</a:t>
              </a:r>
              <a:r>
                <a:rPr lang="en-US" altLang="ko-KR" sz="7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OMT   AAL1   AAL2</a:t>
              </a:r>
              <a:endParaRPr lang="ko-KR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" name="그룹 6"/>
          <p:cNvGrpSpPr/>
          <p:nvPr/>
        </p:nvGrpSpPr>
        <p:grpSpPr>
          <a:xfrm>
            <a:off x="9042253" y="1033792"/>
            <a:ext cx="2570767" cy="2431721"/>
            <a:chOff x="9042253" y="1033792"/>
            <a:chExt cx="2570767" cy="2431721"/>
          </a:xfrm>
        </p:grpSpPr>
        <p:grpSp>
          <p:nvGrpSpPr>
            <p:cNvPr id="68" name="그룹 67"/>
            <p:cNvGrpSpPr/>
            <p:nvPr/>
          </p:nvGrpSpPr>
          <p:grpSpPr>
            <a:xfrm>
              <a:off x="9042253" y="1033792"/>
              <a:ext cx="2570767" cy="2208293"/>
              <a:chOff x="8412463" y="3211800"/>
              <a:chExt cx="2570767" cy="2208293"/>
            </a:xfrm>
          </p:grpSpPr>
          <p:pic>
            <p:nvPicPr>
              <p:cNvPr id="41" name="그림 40"/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785" t="1924" r="22526" b="35359"/>
              <a:stretch/>
            </p:blipFill>
            <p:spPr>
              <a:xfrm>
                <a:off x="8911018" y="3519576"/>
                <a:ext cx="2072212" cy="1900517"/>
              </a:xfrm>
              <a:prstGeom prst="rect">
                <a:avLst/>
              </a:prstGeom>
            </p:spPr>
          </p:pic>
          <p:sp>
            <p:nvSpPr>
              <p:cNvPr id="64" name="TextBox 63"/>
              <p:cNvSpPr txBox="1"/>
              <p:nvPr/>
            </p:nvSpPr>
            <p:spPr>
              <a:xfrm>
                <a:off x="8911018" y="3211800"/>
                <a:ext cx="207221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  <a:endParaRPr lang="ko-KR" altLang="en-US" sz="14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5" name="오른쪽 화살표 64"/>
              <p:cNvSpPr/>
              <p:nvPr/>
            </p:nvSpPr>
            <p:spPr>
              <a:xfrm>
                <a:off x="9121241" y="4800658"/>
                <a:ext cx="189961" cy="87415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8412463" y="4636593"/>
                <a:ext cx="72670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200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PDH</a:t>
                </a:r>
              </a:p>
              <a:p>
                <a:pPr algn="r"/>
                <a:r>
                  <a:rPr lang="en-US" altLang="ko-KR" sz="1200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7 </a:t>
                </a:r>
                <a:r>
                  <a:rPr lang="en-US" altLang="ko-KR" sz="1200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ko-KR" altLang="en-US" sz="12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직사각형 66"/>
              <p:cNvSpPr/>
              <p:nvPr/>
            </p:nvSpPr>
            <p:spPr>
              <a:xfrm>
                <a:off x="9374658" y="4727059"/>
                <a:ext cx="1447292" cy="24025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87" name="TextBox 86"/>
            <p:cNvSpPr txBox="1"/>
            <p:nvPr/>
          </p:nvSpPr>
          <p:spPr>
            <a:xfrm>
              <a:off x="9948364" y="3265458"/>
              <a:ext cx="16532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</a:t>
              </a:r>
              <a:r>
                <a:rPr lang="en-US" altLang="ko-KR" sz="7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</a:t>
              </a:r>
              <a:r>
                <a:rPr lang="en-US" altLang="ko-KR" sz="7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FHFr</a:t>
              </a:r>
              <a:r>
                <a:rPr lang="en-US" altLang="ko-KR" sz="7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OMT   AAL1   AAL2</a:t>
              </a:r>
              <a:endParaRPr lang="ko-KR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" name="그룹 5"/>
          <p:cNvGrpSpPr/>
          <p:nvPr/>
        </p:nvGrpSpPr>
        <p:grpSpPr>
          <a:xfrm>
            <a:off x="6190148" y="1046479"/>
            <a:ext cx="2802352" cy="2419034"/>
            <a:chOff x="6190148" y="1046479"/>
            <a:chExt cx="2802352" cy="2419034"/>
          </a:xfrm>
        </p:grpSpPr>
        <p:grpSp>
          <p:nvGrpSpPr>
            <p:cNvPr id="63" name="그룹 62"/>
            <p:cNvGrpSpPr/>
            <p:nvPr/>
          </p:nvGrpSpPr>
          <p:grpSpPr>
            <a:xfrm>
              <a:off x="6190148" y="1046479"/>
              <a:ext cx="2802352" cy="2247948"/>
              <a:chOff x="5540212" y="1097279"/>
              <a:chExt cx="2802352" cy="2247948"/>
            </a:xfrm>
          </p:grpSpPr>
          <p:pic>
            <p:nvPicPr>
              <p:cNvPr id="42" name="그림 41"/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491" t="3189" r="25316" b="29989"/>
              <a:stretch/>
            </p:blipFill>
            <p:spPr>
              <a:xfrm>
                <a:off x="6211839" y="1421537"/>
                <a:ext cx="2130724" cy="1923690"/>
              </a:xfrm>
              <a:prstGeom prst="rect">
                <a:avLst/>
              </a:prstGeom>
            </p:spPr>
          </p:pic>
          <p:sp>
            <p:nvSpPr>
              <p:cNvPr id="59" name="TextBox 58"/>
              <p:cNvSpPr txBox="1"/>
              <p:nvPr/>
            </p:nvSpPr>
            <p:spPr>
              <a:xfrm>
                <a:off x="6211840" y="1097279"/>
                <a:ext cx="213072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b="1" dirty="0" smtClean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SMAD2</a:t>
                </a:r>
                <a:endParaRPr lang="ko-KR" altLang="en-US" sz="14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오른쪽 화살표 59"/>
              <p:cNvSpPr/>
              <p:nvPr/>
            </p:nvSpPr>
            <p:spPr>
              <a:xfrm>
                <a:off x="6362836" y="2512436"/>
                <a:ext cx="189961" cy="87415"/>
              </a:xfrm>
              <a:prstGeom prst="rightArrow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5540212" y="2348371"/>
                <a:ext cx="84055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ko-KR" sz="12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-SMAD2 37-50 </a:t>
                </a:r>
                <a:r>
                  <a:rPr lang="en-US" altLang="ko-KR" sz="1200" dirty="0" err="1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ko-KR" altLang="en-US" sz="12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직사각형 61"/>
              <p:cNvSpPr/>
              <p:nvPr/>
            </p:nvSpPr>
            <p:spPr>
              <a:xfrm>
                <a:off x="6616253" y="2438837"/>
                <a:ext cx="1447292" cy="24025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sp>
          <p:nvSpPr>
            <p:cNvPr id="88" name="TextBox 87"/>
            <p:cNvSpPr txBox="1"/>
            <p:nvPr/>
          </p:nvSpPr>
          <p:spPr>
            <a:xfrm>
              <a:off x="7225257" y="3265458"/>
              <a:ext cx="16532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</a:t>
              </a:r>
              <a:r>
                <a:rPr lang="en-US" altLang="ko-KR" sz="7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</a:t>
              </a:r>
              <a:r>
                <a:rPr lang="en-US" altLang="ko-KR" sz="7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FHFr</a:t>
              </a:r>
              <a:r>
                <a:rPr lang="en-US" altLang="ko-KR" sz="7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OMT   AAL1   AAL2</a:t>
              </a:r>
              <a:endParaRPr lang="ko-KR" altLang="en-US" sz="7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677026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</TotalTime>
  <Words>74</Words>
  <Application>Microsoft Office PowerPoint</Application>
  <PresentationFormat>와이드스크린</PresentationFormat>
  <Paragraphs>3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2</cp:revision>
  <dcterms:created xsi:type="dcterms:W3CDTF">2025-07-14T00:43:19Z</dcterms:created>
  <dcterms:modified xsi:type="dcterms:W3CDTF">2025-08-01T08:05:37Z</dcterms:modified>
</cp:coreProperties>
</file>